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8" r:id="rId5"/>
    <p:sldId id="269" r:id="rId6"/>
    <p:sldId id="270" r:id="rId7"/>
    <p:sldId id="271" r:id="rId8"/>
    <p:sldId id="257" r:id="rId9"/>
    <p:sldId id="258" r:id="rId10"/>
    <p:sldId id="259" r:id="rId11"/>
    <p:sldId id="260" r:id="rId12"/>
    <p:sldId id="262" r:id="rId13"/>
    <p:sldId id="261" r:id="rId14"/>
    <p:sldId id="263" r:id="rId15"/>
    <p:sldId id="264" r:id="rId16"/>
    <p:sldId id="265" r:id="rId17"/>
    <p:sldId id="266" r:id="rId18"/>
    <p:sldId id="267" r:id="rId19"/>
    <p:sldId id="272" r:id="rId20"/>
    <p:sldId id="273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7CBFA49-DB09-48CF-AAB8-57F376C1A2AE}" v="85" dt="2025-07-18T14:41:14.53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668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presProps" Target="presProps.xml"/><Relationship Id="rId27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oulouras, Grigorios" userId="6b492592-ea60-4083-9d49-546cfcedce02" providerId="ADAL" clId="{4B1FDAEC-4F18-4479-B51D-2F760CEC3212}"/>
    <pc:docChg chg="custSel modSld">
      <pc:chgData name="Koulouras, Grigorios" userId="6b492592-ea60-4083-9d49-546cfcedce02" providerId="ADAL" clId="{4B1FDAEC-4F18-4479-B51D-2F760CEC3212}" dt="2025-02-13T14:31:04.270" v="52" actId="20577"/>
      <pc:docMkLst>
        <pc:docMk/>
      </pc:docMkLst>
      <pc:sldChg chg="addSp modSp">
        <pc:chgData name="Koulouras, Grigorios" userId="6b492592-ea60-4083-9d49-546cfcedce02" providerId="ADAL" clId="{4B1FDAEC-4F18-4479-B51D-2F760CEC3212}" dt="2025-02-13T14:29:04.492" v="9"/>
        <pc:sldMkLst>
          <pc:docMk/>
          <pc:sldMk cId="644506372" sldId="257"/>
        </pc:sldMkLst>
      </pc:sldChg>
      <pc:sldChg chg="addSp modSp mod">
        <pc:chgData name="Koulouras, Grigorios" userId="6b492592-ea60-4083-9d49-546cfcedce02" providerId="ADAL" clId="{4B1FDAEC-4F18-4479-B51D-2F760CEC3212}" dt="2025-02-13T14:29:39.355" v="25" actId="20577"/>
        <pc:sldMkLst>
          <pc:docMk/>
          <pc:sldMk cId="33459489" sldId="258"/>
        </pc:sldMkLst>
      </pc:sldChg>
      <pc:sldChg chg="addSp modSp mod">
        <pc:chgData name="Koulouras, Grigorios" userId="6b492592-ea60-4083-9d49-546cfcedce02" providerId="ADAL" clId="{4B1FDAEC-4F18-4479-B51D-2F760CEC3212}" dt="2025-02-13T14:29:42.602" v="26" actId="20577"/>
        <pc:sldMkLst>
          <pc:docMk/>
          <pc:sldMk cId="3127127167" sldId="259"/>
        </pc:sldMkLst>
      </pc:sldChg>
      <pc:sldChg chg="addSp modSp mod">
        <pc:chgData name="Koulouras, Grigorios" userId="6b492592-ea60-4083-9d49-546cfcedce02" providerId="ADAL" clId="{4B1FDAEC-4F18-4479-B51D-2F760CEC3212}" dt="2025-02-13T14:29:45.698" v="27" actId="20577"/>
        <pc:sldMkLst>
          <pc:docMk/>
          <pc:sldMk cId="1310340394" sldId="260"/>
        </pc:sldMkLst>
      </pc:sldChg>
      <pc:sldChg chg="addSp delSp modSp mod">
        <pc:chgData name="Koulouras, Grigorios" userId="6b492592-ea60-4083-9d49-546cfcedce02" providerId="ADAL" clId="{4B1FDAEC-4F18-4479-B51D-2F760CEC3212}" dt="2025-02-13T14:29:52.818" v="29" actId="20577"/>
        <pc:sldMkLst>
          <pc:docMk/>
          <pc:sldMk cId="2554718167" sldId="261"/>
        </pc:sldMkLst>
      </pc:sldChg>
      <pc:sldChg chg="addSp modSp mod">
        <pc:chgData name="Koulouras, Grigorios" userId="6b492592-ea60-4083-9d49-546cfcedce02" providerId="ADAL" clId="{4B1FDAEC-4F18-4479-B51D-2F760CEC3212}" dt="2025-02-13T14:29:49.185" v="28" actId="20577"/>
        <pc:sldMkLst>
          <pc:docMk/>
          <pc:sldMk cId="955793861" sldId="262"/>
        </pc:sldMkLst>
      </pc:sldChg>
      <pc:sldChg chg="addSp modSp mod">
        <pc:chgData name="Koulouras, Grigorios" userId="6b492592-ea60-4083-9d49-546cfcedce02" providerId="ADAL" clId="{4B1FDAEC-4F18-4479-B51D-2F760CEC3212}" dt="2025-02-13T14:29:56.120" v="30" actId="20577"/>
        <pc:sldMkLst>
          <pc:docMk/>
          <pc:sldMk cId="2348891189" sldId="263"/>
        </pc:sldMkLst>
      </pc:sldChg>
      <pc:sldChg chg="addSp modSp mod">
        <pc:chgData name="Koulouras, Grigorios" userId="6b492592-ea60-4083-9d49-546cfcedce02" providerId="ADAL" clId="{4B1FDAEC-4F18-4479-B51D-2F760CEC3212}" dt="2025-02-13T14:30:00.746" v="31" actId="20577"/>
        <pc:sldMkLst>
          <pc:docMk/>
          <pc:sldMk cId="766781062" sldId="264"/>
        </pc:sldMkLst>
      </pc:sldChg>
      <pc:sldChg chg="addSp modSp mod">
        <pc:chgData name="Koulouras, Grigorios" userId="6b492592-ea60-4083-9d49-546cfcedce02" providerId="ADAL" clId="{4B1FDAEC-4F18-4479-B51D-2F760CEC3212}" dt="2025-02-13T14:30:36.400" v="37" actId="20577"/>
        <pc:sldMkLst>
          <pc:docMk/>
          <pc:sldMk cId="196651308" sldId="265"/>
        </pc:sldMkLst>
      </pc:sldChg>
      <pc:sldChg chg="addSp modSp mod">
        <pc:chgData name="Koulouras, Grigorios" userId="6b492592-ea60-4083-9d49-546cfcedce02" providerId="ADAL" clId="{4B1FDAEC-4F18-4479-B51D-2F760CEC3212}" dt="2025-02-13T14:30:39.987" v="39" actId="20577"/>
        <pc:sldMkLst>
          <pc:docMk/>
          <pc:sldMk cId="148565445" sldId="266"/>
        </pc:sldMkLst>
      </pc:sldChg>
      <pc:sldChg chg="addSp modSp mod">
        <pc:chgData name="Koulouras, Grigorios" userId="6b492592-ea60-4083-9d49-546cfcedce02" providerId="ADAL" clId="{4B1FDAEC-4F18-4479-B51D-2F760CEC3212}" dt="2025-02-13T14:30:44.026" v="41" actId="20577"/>
        <pc:sldMkLst>
          <pc:docMk/>
          <pc:sldMk cId="4100192692" sldId="267"/>
        </pc:sldMkLst>
      </pc:sldChg>
      <pc:sldChg chg="addSp modSp mod">
        <pc:chgData name="Koulouras, Grigorios" userId="6b492592-ea60-4083-9d49-546cfcedce02" providerId="ADAL" clId="{4B1FDAEC-4F18-4479-B51D-2F760CEC3212}" dt="2025-02-13T14:30:48.987" v="45" actId="20577"/>
        <pc:sldMkLst>
          <pc:docMk/>
          <pc:sldMk cId="1485672824" sldId="268"/>
        </pc:sldMkLst>
      </pc:sldChg>
      <pc:sldChg chg="addSp modSp mod">
        <pc:chgData name="Koulouras, Grigorios" userId="6b492592-ea60-4083-9d49-546cfcedce02" providerId="ADAL" clId="{4B1FDAEC-4F18-4479-B51D-2F760CEC3212}" dt="2025-02-13T14:30:53.925" v="49" actId="20577"/>
        <pc:sldMkLst>
          <pc:docMk/>
          <pc:sldMk cId="1477253491" sldId="269"/>
        </pc:sldMkLst>
      </pc:sldChg>
      <pc:sldChg chg="addSp modSp mod">
        <pc:chgData name="Koulouras, Grigorios" userId="6b492592-ea60-4083-9d49-546cfcedce02" providerId="ADAL" clId="{4B1FDAEC-4F18-4479-B51D-2F760CEC3212}" dt="2025-02-13T14:31:00.071" v="51" actId="20577"/>
        <pc:sldMkLst>
          <pc:docMk/>
          <pc:sldMk cId="639706638" sldId="270"/>
        </pc:sldMkLst>
      </pc:sldChg>
      <pc:sldChg chg="addSp modSp mod">
        <pc:chgData name="Koulouras, Grigorios" userId="6b492592-ea60-4083-9d49-546cfcedce02" providerId="ADAL" clId="{4B1FDAEC-4F18-4479-B51D-2F760CEC3212}" dt="2025-02-13T14:31:04.270" v="52" actId="20577"/>
        <pc:sldMkLst>
          <pc:docMk/>
          <pc:sldMk cId="3675977281" sldId="271"/>
        </pc:sldMkLst>
      </pc:sldChg>
    </pc:docChg>
  </pc:docChgLst>
  <pc:docChgLst>
    <pc:chgData name="Xu, Mary (Yingrong)" userId="e127edaf-c1f1-4a6b-8b45-72ba09a302e2" providerId="ADAL" clId="{CA3AD4FA-8DB1-4EEF-8452-571A1E9E43B4}"/>
    <pc:docChg chg="custSel addSld delSld modSld">
      <pc:chgData name="Xu, Mary (Yingrong)" userId="e127edaf-c1f1-4a6b-8b45-72ba09a302e2" providerId="ADAL" clId="{CA3AD4FA-8DB1-4EEF-8452-571A1E9E43B4}" dt="2024-08-28T20:17:19.130" v="225"/>
      <pc:docMkLst>
        <pc:docMk/>
      </pc:docMkLst>
      <pc:sldChg chg="new del">
        <pc:chgData name="Xu, Mary (Yingrong)" userId="e127edaf-c1f1-4a6b-8b45-72ba09a302e2" providerId="ADAL" clId="{CA3AD4FA-8DB1-4EEF-8452-571A1E9E43B4}" dt="2024-08-28T19:37:43.123" v="46" actId="47"/>
        <pc:sldMkLst>
          <pc:docMk/>
          <pc:sldMk cId="2805859263" sldId="256"/>
        </pc:sldMkLst>
      </pc:sldChg>
      <pc:sldChg chg="del">
        <pc:chgData name="Xu, Mary (Yingrong)" userId="e127edaf-c1f1-4a6b-8b45-72ba09a302e2" providerId="ADAL" clId="{CA3AD4FA-8DB1-4EEF-8452-571A1E9E43B4}" dt="2024-08-28T19:21:24.758" v="0" actId="47"/>
        <pc:sldMkLst>
          <pc:docMk/>
          <pc:sldMk cId="3623795861" sldId="256"/>
        </pc:sldMkLst>
      </pc:sldChg>
      <pc:sldChg chg="addSp delSp modSp new mod">
        <pc:chgData name="Xu, Mary (Yingrong)" userId="e127edaf-c1f1-4a6b-8b45-72ba09a302e2" providerId="ADAL" clId="{CA3AD4FA-8DB1-4EEF-8452-571A1E9E43B4}" dt="2024-08-28T19:58:30.448" v="186" actId="1076"/>
        <pc:sldMkLst>
          <pc:docMk/>
          <pc:sldMk cId="644506372" sldId="257"/>
        </pc:sldMkLst>
      </pc:sldChg>
      <pc:sldChg chg="addSp delSp modSp new mod">
        <pc:chgData name="Xu, Mary (Yingrong)" userId="e127edaf-c1f1-4a6b-8b45-72ba09a302e2" providerId="ADAL" clId="{CA3AD4FA-8DB1-4EEF-8452-571A1E9E43B4}" dt="2024-08-28T20:00:46.589" v="193" actId="1076"/>
        <pc:sldMkLst>
          <pc:docMk/>
          <pc:sldMk cId="33459489" sldId="258"/>
        </pc:sldMkLst>
      </pc:sldChg>
      <pc:sldChg chg="addSp delSp modSp new mod">
        <pc:chgData name="Xu, Mary (Yingrong)" userId="e127edaf-c1f1-4a6b-8b45-72ba09a302e2" providerId="ADAL" clId="{CA3AD4FA-8DB1-4EEF-8452-571A1E9E43B4}" dt="2024-08-28T19:56:17.552" v="178" actId="1076"/>
        <pc:sldMkLst>
          <pc:docMk/>
          <pc:sldMk cId="3127127167" sldId="259"/>
        </pc:sldMkLst>
      </pc:sldChg>
      <pc:sldChg chg="addSp delSp modSp new mod">
        <pc:chgData name="Xu, Mary (Yingrong)" userId="e127edaf-c1f1-4a6b-8b45-72ba09a302e2" providerId="ADAL" clId="{CA3AD4FA-8DB1-4EEF-8452-571A1E9E43B4}" dt="2024-08-28T20:13:57.246" v="208" actId="1076"/>
        <pc:sldMkLst>
          <pc:docMk/>
          <pc:sldMk cId="1310340394" sldId="260"/>
        </pc:sldMkLst>
      </pc:sldChg>
      <pc:sldChg chg="addSp delSp modSp new mod">
        <pc:chgData name="Xu, Mary (Yingrong)" userId="e127edaf-c1f1-4a6b-8b45-72ba09a302e2" providerId="ADAL" clId="{CA3AD4FA-8DB1-4EEF-8452-571A1E9E43B4}" dt="2024-08-28T20:17:13.072" v="224" actId="1076"/>
        <pc:sldMkLst>
          <pc:docMk/>
          <pc:sldMk cId="2554718167" sldId="261"/>
        </pc:sldMkLst>
      </pc:sldChg>
      <pc:sldChg chg="addSp delSp modSp new mod">
        <pc:chgData name="Xu, Mary (Yingrong)" userId="e127edaf-c1f1-4a6b-8b45-72ba09a302e2" providerId="ADAL" clId="{CA3AD4FA-8DB1-4EEF-8452-571A1E9E43B4}" dt="2024-08-28T20:17:19.130" v="225"/>
        <pc:sldMkLst>
          <pc:docMk/>
          <pc:sldMk cId="955793861" sldId="262"/>
        </pc:sldMkLst>
      </pc:sldChg>
    </pc:docChg>
  </pc:docChgLst>
  <pc:docChgLst>
    <pc:chgData name="Koulouras, Grigorios" userId="6b492592-ea60-4083-9d49-546cfcedce02" providerId="ADAL" clId="{D7CBFA49-DB09-48CF-AAB8-57F376C1A2AE}"/>
    <pc:docChg chg="custSel addSld delSld modSld sldOrd">
      <pc:chgData name="Koulouras, Grigorios" userId="6b492592-ea60-4083-9d49-546cfcedce02" providerId="ADAL" clId="{D7CBFA49-DB09-48CF-AAB8-57F376C1A2AE}" dt="2025-07-18T14:45:14.372" v="605" actId="20577"/>
      <pc:docMkLst>
        <pc:docMk/>
      </pc:docMkLst>
      <pc:sldChg chg="modSp mod">
        <pc:chgData name="Koulouras, Grigorios" userId="6b492592-ea60-4083-9d49-546cfcedce02" providerId="ADAL" clId="{D7CBFA49-DB09-48CF-AAB8-57F376C1A2AE}" dt="2025-07-17T21:21:05.361" v="44" actId="20577"/>
        <pc:sldMkLst>
          <pc:docMk/>
          <pc:sldMk cId="644506372" sldId="257"/>
        </pc:sldMkLst>
        <pc:spChg chg="mod">
          <ac:chgData name="Koulouras, Grigorios" userId="6b492592-ea60-4083-9d49-546cfcedce02" providerId="ADAL" clId="{D7CBFA49-DB09-48CF-AAB8-57F376C1A2AE}" dt="2025-07-17T21:21:05.361" v="44" actId="20577"/>
          <ac:spMkLst>
            <pc:docMk/>
            <pc:sldMk cId="644506372" sldId="257"/>
            <ac:spMk id="2" creationId="{F10487DD-B4E5-AA51-405F-0DE9B3023993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09.926" v="45" actId="20577"/>
        <pc:sldMkLst>
          <pc:docMk/>
          <pc:sldMk cId="33459489" sldId="258"/>
        </pc:sldMkLst>
        <pc:spChg chg="mod">
          <ac:chgData name="Koulouras, Grigorios" userId="6b492592-ea60-4083-9d49-546cfcedce02" providerId="ADAL" clId="{D7CBFA49-DB09-48CF-AAB8-57F376C1A2AE}" dt="2025-07-17T21:21:09.926" v="45" actId="20577"/>
          <ac:spMkLst>
            <pc:docMk/>
            <pc:sldMk cId="33459489" sldId="258"/>
            <ac:spMk id="2" creationId="{708F7193-537D-9519-FD23-B87FF85529B2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13.953" v="46" actId="20577"/>
        <pc:sldMkLst>
          <pc:docMk/>
          <pc:sldMk cId="3127127167" sldId="259"/>
        </pc:sldMkLst>
        <pc:spChg chg="mod">
          <ac:chgData name="Koulouras, Grigorios" userId="6b492592-ea60-4083-9d49-546cfcedce02" providerId="ADAL" clId="{D7CBFA49-DB09-48CF-AAB8-57F376C1A2AE}" dt="2025-07-17T21:21:13.953" v="46" actId="20577"/>
          <ac:spMkLst>
            <pc:docMk/>
            <pc:sldMk cId="3127127167" sldId="259"/>
            <ac:spMk id="2" creationId="{B3DD8D53-5F7D-9DBA-D946-239F86EF7C35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17.252" v="47" actId="20577"/>
        <pc:sldMkLst>
          <pc:docMk/>
          <pc:sldMk cId="1310340394" sldId="260"/>
        </pc:sldMkLst>
        <pc:spChg chg="mod">
          <ac:chgData name="Koulouras, Grigorios" userId="6b492592-ea60-4083-9d49-546cfcedce02" providerId="ADAL" clId="{D7CBFA49-DB09-48CF-AAB8-57F376C1A2AE}" dt="2025-07-17T21:21:17.252" v="47" actId="20577"/>
          <ac:spMkLst>
            <pc:docMk/>
            <pc:sldMk cId="1310340394" sldId="260"/>
            <ac:spMk id="2" creationId="{FF3D1E1C-B12F-8864-8F56-EF545B03CF87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24.998" v="50" actId="20577"/>
        <pc:sldMkLst>
          <pc:docMk/>
          <pc:sldMk cId="2554718167" sldId="261"/>
        </pc:sldMkLst>
        <pc:spChg chg="mod">
          <ac:chgData name="Koulouras, Grigorios" userId="6b492592-ea60-4083-9d49-546cfcedce02" providerId="ADAL" clId="{D7CBFA49-DB09-48CF-AAB8-57F376C1A2AE}" dt="2025-07-17T21:21:24.998" v="50" actId="20577"/>
          <ac:spMkLst>
            <pc:docMk/>
            <pc:sldMk cId="2554718167" sldId="261"/>
            <ac:spMk id="3" creationId="{CC77D2DE-C8FB-1328-985E-89F1A30A2C56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21.132" v="48" actId="20577"/>
        <pc:sldMkLst>
          <pc:docMk/>
          <pc:sldMk cId="955793861" sldId="262"/>
        </pc:sldMkLst>
        <pc:spChg chg="mod">
          <ac:chgData name="Koulouras, Grigorios" userId="6b492592-ea60-4083-9d49-546cfcedce02" providerId="ADAL" clId="{D7CBFA49-DB09-48CF-AAB8-57F376C1A2AE}" dt="2025-07-17T21:21:21.132" v="48" actId="20577"/>
          <ac:spMkLst>
            <pc:docMk/>
            <pc:sldMk cId="955793861" sldId="262"/>
            <ac:spMk id="2" creationId="{712299EE-0D28-B32A-361E-238FB43FB2C8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28.159" v="52" actId="20577"/>
        <pc:sldMkLst>
          <pc:docMk/>
          <pc:sldMk cId="2348891189" sldId="263"/>
        </pc:sldMkLst>
        <pc:spChg chg="mod">
          <ac:chgData name="Koulouras, Grigorios" userId="6b492592-ea60-4083-9d49-546cfcedce02" providerId="ADAL" clId="{D7CBFA49-DB09-48CF-AAB8-57F376C1A2AE}" dt="2025-07-17T21:21:28.159" v="52" actId="20577"/>
          <ac:spMkLst>
            <pc:docMk/>
            <pc:sldMk cId="2348891189" sldId="263"/>
            <ac:spMk id="3" creationId="{4CB4C758-79C6-9988-381C-EA933F02028A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34.866" v="54" actId="20577"/>
        <pc:sldMkLst>
          <pc:docMk/>
          <pc:sldMk cId="766781062" sldId="264"/>
        </pc:sldMkLst>
        <pc:spChg chg="mod">
          <ac:chgData name="Koulouras, Grigorios" userId="6b492592-ea60-4083-9d49-546cfcedce02" providerId="ADAL" clId="{D7CBFA49-DB09-48CF-AAB8-57F376C1A2AE}" dt="2025-07-17T21:21:34.866" v="54" actId="20577"/>
          <ac:spMkLst>
            <pc:docMk/>
            <pc:sldMk cId="766781062" sldId="264"/>
            <ac:spMk id="3" creationId="{DD5CAA48-22EE-E2FB-BA55-A470B401666F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39.016" v="58" actId="20577"/>
        <pc:sldMkLst>
          <pc:docMk/>
          <pc:sldMk cId="196651308" sldId="265"/>
        </pc:sldMkLst>
        <pc:spChg chg="mod">
          <ac:chgData name="Koulouras, Grigorios" userId="6b492592-ea60-4083-9d49-546cfcedce02" providerId="ADAL" clId="{D7CBFA49-DB09-48CF-AAB8-57F376C1A2AE}" dt="2025-07-17T21:21:39.016" v="58" actId="20577"/>
          <ac:spMkLst>
            <pc:docMk/>
            <pc:sldMk cId="196651308" sldId="265"/>
            <ac:spMk id="3" creationId="{A39F5C02-C0DF-D6BD-B582-5B2C0503C736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43.087" v="60" actId="20577"/>
        <pc:sldMkLst>
          <pc:docMk/>
          <pc:sldMk cId="148565445" sldId="266"/>
        </pc:sldMkLst>
        <pc:spChg chg="mod">
          <ac:chgData name="Koulouras, Grigorios" userId="6b492592-ea60-4083-9d49-546cfcedce02" providerId="ADAL" clId="{D7CBFA49-DB09-48CF-AAB8-57F376C1A2AE}" dt="2025-07-17T21:21:43.087" v="60" actId="20577"/>
          <ac:spMkLst>
            <pc:docMk/>
            <pc:sldMk cId="148565445" sldId="266"/>
            <ac:spMk id="3" creationId="{13CFBBD6-7618-5DBB-95F5-2238E0F90AA8}"/>
          </ac:spMkLst>
        </pc:spChg>
      </pc:sldChg>
      <pc:sldChg chg="modSp mod">
        <pc:chgData name="Koulouras, Grigorios" userId="6b492592-ea60-4083-9d49-546cfcedce02" providerId="ADAL" clId="{D7CBFA49-DB09-48CF-AAB8-57F376C1A2AE}" dt="2025-07-17T21:21:46.655" v="62" actId="20577"/>
        <pc:sldMkLst>
          <pc:docMk/>
          <pc:sldMk cId="4100192692" sldId="267"/>
        </pc:sldMkLst>
        <pc:spChg chg="mod">
          <ac:chgData name="Koulouras, Grigorios" userId="6b492592-ea60-4083-9d49-546cfcedce02" providerId="ADAL" clId="{D7CBFA49-DB09-48CF-AAB8-57F376C1A2AE}" dt="2025-07-17T21:21:46.655" v="62" actId="20577"/>
          <ac:spMkLst>
            <pc:docMk/>
            <pc:sldMk cId="4100192692" sldId="267"/>
            <ac:spMk id="3" creationId="{D0AC84FB-A488-8B1B-A259-C739ED75B180}"/>
          </ac:spMkLst>
        </pc:spChg>
      </pc:sldChg>
      <pc:sldChg chg="addSp delSp modSp mod ord">
        <pc:chgData name="Koulouras, Grigorios" userId="6b492592-ea60-4083-9d49-546cfcedce02" providerId="ADAL" clId="{D7CBFA49-DB09-48CF-AAB8-57F376C1A2AE}" dt="2025-07-17T20:54:48.241" v="28" actId="1076"/>
        <pc:sldMkLst>
          <pc:docMk/>
          <pc:sldMk cId="1485672824" sldId="268"/>
        </pc:sldMkLst>
        <pc:spChg chg="mod">
          <ac:chgData name="Koulouras, Grigorios" userId="6b492592-ea60-4083-9d49-546cfcedce02" providerId="ADAL" clId="{D7CBFA49-DB09-48CF-AAB8-57F376C1A2AE}" dt="2025-07-17T20:54:26.897" v="21" actId="1076"/>
          <ac:spMkLst>
            <pc:docMk/>
            <pc:sldMk cId="1485672824" sldId="268"/>
            <ac:spMk id="2" creationId="{EEBB67FC-04DF-9DEC-D301-84A7D0D7F919}"/>
          </ac:spMkLst>
        </pc:spChg>
        <pc:spChg chg="mod">
          <ac:chgData name="Koulouras, Grigorios" userId="6b492592-ea60-4083-9d49-546cfcedce02" providerId="ADAL" clId="{D7CBFA49-DB09-48CF-AAB8-57F376C1A2AE}" dt="2025-07-17T20:21:24.438" v="2" actId="6549"/>
          <ac:spMkLst>
            <pc:docMk/>
            <pc:sldMk cId="1485672824" sldId="268"/>
            <ac:spMk id="3" creationId="{5DE7CE59-36AE-81A1-F35A-A9D1DE5D5B0A}"/>
          </ac:spMkLst>
        </pc:spChg>
        <pc:picChg chg="del">
          <ac:chgData name="Koulouras, Grigorios" userId="6b492592-ea60-4083-9d49-546cfcedce02" providerId="ADAL" clId="{D7CBFA49-DB09-48CF-AAB8-57F376C1A2AE}" dt="2025-07-17T20:53:38.295" v="9" actId="478"/>
          <ac:picMkLst>
            <pc:docMk/>
            <pc:sldMk cId="1485672824" sldId="268"/>
            <ac:picMk id="5" creationId="{BA90483C-FC11-6378-49C5-73B7E13B77A1}"/>
          </ac:picMkLst>
        </pc:picChg>
        <pc:picChg chg="add mod">
          <ac:chgData name="Koulouras, Grigorios" userId="6b492592-ea60-4083-9d49-546cfcedce02" providerId="ADAL" clId="{D7CBFA49-DB09-48CF-AAB8-57F376C1A2AE}" dt="2025-07-17T20:54:48.241" v="28" actId="1076"/>
          <ac:picMkLst>
            <pc:docMk/>
            <pc:sldMk cId="1485672824" sldId="268"/>
            <ac:picMk id="6" creationId="{21F4308F-BE5D-67BD-9594-4BB66895B07C}"/>
          </ac:picMkLst>
        </pc:picChg>
      </pc:sldChg>
      <pc:sldChg chg="modSp del mod ord">
        <pc:chgData name="Koulouras, Grigorios" userId="6b492592-ea60-4083-9d49-546cfcedce02" providerId="ADAL" clId="{D7CBFA49-DB09-48CF-AAB8-57F376C1A2AE}" dt="2025-07-17T20:46:33.267" v="6" actId="47"/>
        <pc:sldMkLst>
          <pc:docMk/>
          <pc:sldMk cId="1477253491" sldId="269"/>
        </pc:sldMkLst>
        <pc:spChg chg="mod">
          <ac:chgData name="Koulouras, Grigorios" userId="6b492592-ea60-4083-9d49-546cfcedce02" providerId="ADAL" clId="{D7CBFA49-DB09-48CF-AAB8-57F376C1A2AE}" dt="2025-07-17T20:21:27.798" v="3" actId="20577"/>
          <ac:spMkLst>
            <pc:docMk/>
            <pc:sldMk cId="1477253491" sldId="269"/>
            <ac:spMk id="3" creationId="{1D8EDC60-7739-F355-03A4-55AF3630FE37}"/>
          </ac:spMkLst>
        </pc:spChg>
      </pc:sldChg>
      <pc:sldChg chg="addSp delSp modSp add mod">
        <pc:chgData name="Koulouras, Grigorios" userId="6b492592-ea60-4083-9d49-546cfcedce02" providerId="ADAL" clId="{D7CBFA49-DB09-48CF-AAB8-57F376C1A2AE}" dt="2025-07-17T20:56:53.842" v="34" actId="1076"/>
        <pc:sldMkLst>
          <pc:docMk/>
          <pc:sldMk cId="1632344134" sldId="269"/>
        </pc:sldMkLst>
        <pc:spChg chg="mod">
          <ac:chgData name="Koulouras, Grigorios" userId="6b492592-ea60-4083-9d49-546cfcedce02" providerId="ADAL" clId="{D7CBFA49-DB09-48CF-AAB8-57F376C1A2AE}" dt="2025-07-17T20:55:59.251" v="30" actId="20577"/>
          <ac:spMkLst>
            <pc:docMk/>
            <pc:sldMk cId="1632344134" sldId="269"/>
            <ac:spMk id="3" creationId="{4495596D-BE32-1C96-9D26-F647107500F1}"/>
          </ac:spMkLst>
        </pc:spChg>
        <pc:picChg chg="add mod">
          <ac:chgData name="Koulouras, Grigorios" userId="6b492592-ea60-4083-9d49-546cfcedce02" providerId="ADAL" clId="{D7CBFA49-DB09-48CF-AAB8-57F376C1A2AE}" dt="2025-07-17T20:56:53.842" v="34" actId="1076"/>
          <ac:picMkLst>
            <pc:docMk/>
            <pc:sldMk cId="1632344134" sldId="269"/>
            <ac:picMk id="5" creationId="{F2FEDC43-1DEB-C95F-D279-ABC3C1BC4F93}"/>
          </ac:picMkLst>
        </pc:picChg>
        <pc:picChg chg="del">
          <ac:chgData name="Koulouras, Grigorios" userId="6b492592-ea60-4083-9d49-546cfcedce02" providerId="ADAL" clId="{D7CBFA49-DB09-48CF-AAB8-57F376C1A2AE}" dt="2025-07-17T20:56:48.440" v="33" actId="478"/>
          <ac:picMkLst>
            <pc:docMk/>
            <pc:sldMk cId="1632344134" sldId="269"/>
            <ac:picMk id="6" creationId="{C3C43C3D-C353-0D65-0552-7613E5C3FA30}"/>
          </ac:picMkLst>
        </pc:picChg>
      </pc:sldChg>
      <pc:sldChg chg="modSp del mod ord">
        <pc:chgData name="Koulouras, Grigorios" userId="6b492592-ea60-4083-9d49-546cfcedce02" providerId="ADAL" clId="{D7CBFA49-DB09-48CF-AAB8-57F376C1A2AE}" dt="2025-07-17T20:46:34.396" v="7" actId="47"/>
        <pc:sldMkLst>
          <pc:docMk/>
          <pc:sldMk cId="639706638" sldId="270"/>
        </pc:sldMkLst>
        <pc:spChg chg="mod">
          <ac:chgData name="Koulouras, Grigorios" userId="6b492592-ea60-4083-9d49-546cfcedce02" providerId="ADAL" clId="{D7CBFA49-DB09-48CF-AAB8-57F376C1A2AE}" dt="2025-07-17T20:21:31.126" v="4" actId="20577"/>
          <ac:spMkLst>
            <pc:docMk/>
            <pc:sldMk cId="639706638" sldId="270"/>
            <ac:spMk id="3" creationId="{DC8C88BD-C343-013E-8660-16D684E7BE5E}"/>
          </ac:spMkLst>
        </pc:spChg>
      </pc:sldChg>
      <pc:sldChg chg="addSp delSp modSp add mod">
        <pc:chgData name="Koulouras, Grigorios" userId="6b492592-ea60-4083-9d49-546cfcedce02" providerId="ADAL" clId="{D7CBFA49-DB09-48CF-AAB8-57F376C1A2AE}" dt="2025-07-17T21:00:31.292" v="39" actId="1076"/>
        <pc:sldMkLst>
          <pc:docMk/>
          <pc:sldMk cId="3849597838" sldId="270"/>
        </pc:sldMkLst>
        <pc:spChg chg="mod">
          <ac:chgData name="Koulouras, Grigorios" userId="6b492592-ea60-4083-9d49-546cfcedce02" providerId="ADAL" clId="{D7CBFA49-DB09-48CF-AAB8-57F376C1A2AE}" dt="2025-07-17T20:57:11.005" v="36" actId="20577"/>
          <ac:spMkLst>
            <pc:docMk/>
            <pc:sldMk cId="3849597838" sldId="270"/>
            <ac:spMk id="3" creationId="{F5514E98-D2DB-95BD-CA29-D6FBEC235F07}"/>
          </ac:spMkLst>
        </pc:spChg>
        <pc:picChg chg="del">
          <ac:chgData name="Koulouras, Grigorios" userId="6b492592-ea60-4083-9d49-546cfcedce02" providerId="ADAL" clId="{D7CBFA49-DB09-48CF-AAB8-57F376C1A2AE}" dt="2025-07-17T21:00:23.627" v="37" actId="478"/>
          <ac:picMkLst>
            <pc:docMk/>
            <pc:sldMk cId="3849597838" sldId="270"/>
            <ac:picMk id="5" creationId="{56883B75-3341-E751-52F1-B6327DD868D4}"/>
          </ac:picMkLst>
        </pc:picChg>
        <pc:picChg chg="add mod">
          <ac:chgData name="Koulouras, Grigorios" userId="6b492592-ea60-4083-9d49-546cfcedce02" providerId="ADAL" clId="{D7CBFA49-DB09-48CF-AAB8-57F376C1A2AE}" dt="2025-07-17T21:00:31.292" v="39" actId="1076"/>
          <ac:picMkLst>
            <pc:docMk/>
            <pc:sldMk cId="3849597838" sldId="270"/>
            <ac:picMk id="6" creationId="{6463527B-AFBF-BBE4-9557-922F58871007}"/>
          </ac:picMkLst>
        </pc:picChg>
      </pc:sldChg>
      <pc:sldChg chg="addSp delSp modSp add mod">
        <pc:chgData name="Koulouras, Grigorios" userId="6b492592-ea60-4083-9d49-546cfcedce02" providerId="ADAL" clId="{D7CBFA49-DB09-48CF-AAB8-57F376C1A2AE}" dt="2025-07-17T21:02:59.479" v="43" actId="20577"/>
        <pc:sldMkLst>
          <pc:docMk/>
          <pc:sldMk cId="2828304129" sldId="271"/>
        </pc:sldMkLst>
        <pc:spChg chg="mod">
          <ac:chgData name="Koulouras, Grigorios" userId="6b492592-ea60-4083-9d49-546cfcedce02" providerId="ADAL" clId="{D7CBFA49-DB09-48CF-AAB8-57F376C1A2AE}" dt="2025-07-17T21:02:59.479" v="43" actId="20577"/>
          <ac:spMkLst>
            <pc:docMk/>
            <pc:sldMk cId="2828304129" sldId="271"/>
            <ac:spMk id="3" creationId="{E008ABE2-1DA1-BB17-0D7C-6C9A9F08331F}"/>
          </ac:spMkLst>
        </pc:spChg>
        <pc:picChg chg="add">
          <ac:chgData name="Koulouras, Grigorios" userId="6b492592-ea60-4083-9d49-546cfcedce02" providerId="ADAL" clId="{D7CBFA49-DB09-48CF-AAB8-57F376C1A2AE}" dt="2025-07-17T21:02:23.216" v="42" actId="22"/>
          <ac:picMkLst>
            <pc:docMk/>
            <pc:sldMk cId="2828304129" sldId="271"/>
            <ac:picMk id="5" creationId="{DF6C6395-05ED-5E03-FFED-3F415BC95132}"/>
          </ac:picMkLst>
        </pc:picChg>
        <pc:picChg chg="del">
          <ac:chgData name="Koulouras, Grigorios" userId="6b492592-ea60-4083-9d49-546cfcedce02" providerId="ADAL" clId="{D7CBFA49-DB09-48CF-AAB8-57F376C1A2AE}" dt="2025-07-17T21:02:22.598" v="41" actId="478"/>
          <ac:picMkLst>
            <pc:docMk/>
            <pc:sldMk cId="2828304129" sldId="271"/>
            <ac:picMk id="6" creationId="{63CC8C81-B4E7-71A4-30D9-A5EA860F37B8}"/>
          </ac:picMkLst>
        </pc:picChg>
      </pc:sldChg>
      <pc:sldChg chg="modSp del mod ord">
        <pc:chgData name="Koulouras, Grigorios" userId="6b492592-ea60-4083-9d49-546cfcedce02" providerId="ADAL" clId="{D7CBFA49-DB09-48CF-AAB8-57F376C1A2AE}" dt="2025-07-17T20:46:35.293" v="8" actId="47"/>
        <pc:sldMkLst>
          <pc:docMk/>
          <pc:sldMk cId="3675977281" sldId="271"/>
        </pc:sldMkLst>
        <pc:spChg chg="mod">
          <ac:chgData name="Koulouras, Grigorios" userId="6b492592-ea60-4083-9d49-546cfcedce02" providerId="ADAL" clId="{D7CBFA49-DB09-48CF-AAB8-57F376C1A2AE}" dt="2025-07-17T20:21:33.842" v="5" actId="20577"/>
          <ac:spMkLst>
            <pc:docMk/>
            <pc:sldMk cId="3675977281" sldId="271"/>
            <ac:spMk id="3" creationId="{02C994C4-C0F7-DB3E-40FC-7DB8754588F7}"/>
          </ac:spMkLst>
        </pc:spChg>
      </pc:sldChg>
      <pc:sldChg chg="addSp delSp modSp add mod ord">
        <pc:chgData name="Koulouras, Grigorios" userId="6b492592-ea60-4083-9d49-546cfcedce02" providerId="ADAL" clId="{D7CBFA49-DB09-48CF-AAB8-57F376C1A2AE}" dt="2025-07-18T14:44:33.696" v="600"/>
        <pc:sldMkLst>
          <pc:docMk/>
          <pc:sldMk cId="1065543408" sldId="272"/>
        </pc:sldMkLst>
        <pc:spChg chg="mod">
          <ac:chgData name="Koulouras, Grigorios" userId="6b492592-ea60-4083-9d49-546cfcedce02" providerId="ADAL" clId="{D7CBFA49-DB09-48CF-AAB8-57F376C1A2AE}" dt="2025-07-18T14:44:33.696" v="600"/>
          <ac:spMkLst>
            <pc:docMk/>
            <pc:sldMk cId="1065543408" sldId="272"/>
            <ac:spMk id="2" creationId="{BEFF2D53-6ACD-FB11-4D84-CAE93457333F}"/>
          </ac:spMkLst>
        </pc:spChg>
        <pc:spChg chg="mod">
          <ac:chgData name="Koulouras, Grigorios" userId="6b492592-ea60-4083-9d49-546cfcedce02" providerId="ADAL" clId="{D7CBFA49-DB09-48CF-AAB8-57F376C1A2AE}" dt="2025-07-18T14:43:40.990" v="599" actId="20577"/>
          <ac:spMkLst>
            <pc:docMk/>
            <pc:sldMk cId="1065543408" sldId="272"/>
            <ac:spMk id="3" creationId="{591DE2FC-310F-E3EB-D209-AD43CCD76825}"/>
          </ac:spMkLst>
        </pc:spChg>
        <pc:spChg chg="add">
          <ac:chgData name="Koulouras, Grigorios" userId="6b492592-ea60-4083-9d49-546cfcedce02" providerId="ADAL" clId="{D7CBFA49-DB09-48CF-AAB8-57F376C1A2AE}" dt="2025-07-18T10:21:02.910" v="69"/>
          <ac:spMkLst>
            <pc:docMk/>
            <pc:sldMk cId="1065543408" sldId="272"/>
            <ac:spMk id="4" creationId="{D8C1CA4B-5E1E-15D3-3456-98033663919B}"/>
          </ac:spMkLst>
        </pc:spChg>
        <pc:spChg chg="add del mod">
          <ac:chgData name="Koulouras, Grigorios" userId="6b492592-ea60-4083-9d49-546cfcedce02" providerId="ADAL" clId="{D7CBFA49-DB09-48CF-AAB8-57F376C1A2AE}" dt="2025-07-18T10:21:48.120" v="149" actId="478"/>
          <ac:spMkLst>
            <pc:docMk/>
            <pc:sldMk cId="1065543408" sldId="272"/>
            <ac:spMk id="6" creationId="{F08F39EA-3B15-9A4C-426E-EA968B0CAB71}"/>
          </ac:spMkLst>
        </pc:spChg>
        <pc:picChg chg="del">
          <ac:chgData name="Koulouras, Grigorios" userId="6b492592-ea60-4083-9d49-546cfcedce02" providerId="ADAL" clId="{D7CBFA49-DB09-48CF-AAB8-57F376C1A2AE}" dt="2025-07-18T10:21:01.607" v="68" actId="478"/>
          <ac:picMkLst>
            <pc:docMk/>
            <pc:sldMk cId="1065543408" sldId="272"/>
            <ac:picMk id="5" creationId="{C20D24A0-A40C-534E-2951-EA77CAA0F59F}"/>
          </ac:picMkLst>
        </pc:picChg>
        <pc:picChg chg="add">
          <ac:chgData name="Koulouras, Grigorios" userId="6b492592-ea60-4083-9d49-546cfcedce02" providerId="ADAL" clId="{D7CBFA49-DB09-48CF-AAB8-57F376C1A2AE}" dt="2025-07-18T12:41:12.734" v="255" actId="22"/>
          <ac:picMkLst>
            <pc:docMk/>
            <pc:sldMk cId="1065543408" sldId="272"/>
            <ac:picMk id="8" creationId="{6CCA6294-53EA-8E86-A45C-0A6BA54673F0}"/>
          </ac:picMkLst>
        </pc:picChg>
        <pc:picChg chg="add del mod">
          <ac:chgData name="Koulouras, Grigorios" userId="6b492592-ea60-4083-9d49-546cfcedce02" providerId="ADAL" clId="{D7CBFA49-DB09-48CF-AAB8-57F376C1A2AE}" dt="2025-07-18T12:41:11.993" v="254" actId="478"/>
          <ac:picMkLst>
            <pc:docMk/>
            <pc:sldMk cId="1065543408" sldId="272"/>
            <ac:picMk id="1025" creationId="{CCF46B4F-FAF8-28A9-6B79-A031043BFE0B}"/>
          </ac:picMkLst>
        </pc:picChg>
      </pc:sldChg>
      <pc:sldChg chg="addSp modSp add mod">
        <pc:chgData name="Koulouras, Grigorios" userId="6b492592-ea60-4083-9d49-546cfcedce02" providerId="ADAL" clId="{D7CBFA49-DB09-48CF-AAB8-57F376C1A2AE}" dt="2025-07-18T14:45:14.372" v="605" actId="20577"/>
        <pc:sldMkLst>
          <pc:docMk/>
          <pc:sldMk cId="1876583628" sldId="273"/>
        </pc:sldMkLst>
        <pc:spChg chg="mod">
          <ac:chgData name="Koulouras, Grigorios" userId="6b492592-ea60-4083-9d49-546cfcedce02" providerId="ADAL" clId="{D7CBFA49-DB09-48CF-AAB8-57F376C1A2AE}" dt="2025-07-18T14:45:03.499" v="601"/>
          <ac:spMkLst>
            <pc:docMk/>
            <pc:sldMk cId="1876583628" sldId="273"/>
            <ac:spMk id="2" creationId="{1B5ECA68-BFFB-F1D4-8799-216F86ED17AC}"/>
          </ac:spMkLst>
        </pc:spChg>
        <pc:spChg chg="mod">
          <ac:chgData name="Koulouras, Grigorios" userId="6b492592-ea60-4083-9d49-546cfcedce02" providerId="ADAL" clId="{D7CBFA49-DB09-48CF-AAB8-57F376C1A2AE}" dt="2025-07-18T14:45:14.372" v="605" actId="20577"/>
          <ac:spMkLst>
            <pc:docMk/>
            <pc:sldMk cId="1876583628" sldId="273"/>
            <ac:spMk id="3" creationId="{9FA722ED-20F1-A439-98E7-668259A722FC}"/>
          </ac:spMkLst>
        </pc:spChg>
        <pc:picChg chg="add">
          <ac:chgData name="Koulouras, Grigorios" userId="6b492592-ea60-4083-9d49-546cfcedce02" providerId="ADAL" clId="{D7CBFA49-DB09-48CF-AAB8-57F376C1A2AE}" dt="2025-07-18T12:42:58.679" v="303" actId="22"/>
          <ac:picMkLst>
            <pc:docMk/>
            <pc:sldMk cId="1876583628" sldId="273"/>
            <ac:picMk id="6" creationId="{9B6AD968-6EC7-06BD-43CA-D1621ED91C9F}"/>
          </ac:picMkLst>
        </pc:picChg>
      </pc:sldChg>
    </pc:docChg>
  </pc:docChgLst>
  <pc:docChgLst>
    <pc:chgData name="Koulouras, Grigorios" userId="6b492592-ea60-4083-9d49-546cfcedce02" providerId="ADAL" clId="{BA453368-2715-4F84-A1D1-33A36EA6D014}"/>
    <pc:docChg chg="undo custSel addSld modSld">
      <pc:chgData name="Koulouras, Grigorios" userId="6b492592-ea60-4083-9d49-546cfcedce02" providerId="ADAL" clId="{BA453368-2715-4F84-A1D1-33A36EA6D014}" dt="2024-12-09T22:53:02.267" v="4"/>
      <pc:docMkLst>
        <pc:docMk/>
      </pc:docMkLst>
      <pc:sldChg chg="addSp delSp mod">
        <pc:chgData name="Koulouras, Grigorios" userId="6b492592-ea60-4083-9d49-546cfcedce02" providerId="ADAL" clId="{BA453368-2715-4F84-A1D1-33A36EA6D014}" dt="2024-12-09T22:52:37.514" v="3" actId="22"/>
        <pc:sldMkLst>
          <pc:docMk/>
          <pc:sldMk cId="2554718167" sldId="261"/>
        </pc:sldMkLst>
      </pc:sldChg>
      <pc:sldChg chg="add">
        <pc:chgData name="Koulouras, Grigorios" userId="6b492592-ea60-4083-9d49-546cfcedce02" providerId="ADAL" clId="{BA453368-2715-4F84-A1D1-33A36EA6D014}" dt="2024-12-09T22:53:02.267" v="4"/>
        <pc:sldMkLst>
          <pc:docMk/>
          <pc:sldMk cId="2348891189" sldId="263"/>
        </pc:sldMkLst>
      </pc:sldChg>
      <pc:sldChg chg="add">
        <pc:chgData name="Koulouras, Grigorios" userId="6b492592-ea60-4083-9d49-546cfcedce02" providerId="ADAL" clId="{BA453368-2715-4F84-A1D1-33A36EA6D014}" dt="2024-12-09T22:53:02.267" v="4"/>
        <pc:sldMkLst>
          <pc:docMk/>
          <pc:sldMk cId="766781062" sldId="264"/>
        </pc:sldMkLst>
      </pc:sldChg>
      <pc:sldChg chg="add">
        <pc:chgData name="Koulouras, Grigorios" userId="6b492592-ea60-4083-9d49-546cfcedce02" providerId="ADAL" clId="{BA453368-2715-4F84-A1D1-33A36EA6D014}" dt="2024-12-09T22:53:02.267" v="4"/>
        <pc:sldMkLst>
          <pc:docMk/>
          <pc:sldMk cId="196651308" sldId="265"/>
        </pc:sldMkLst>
      </pc:sldChg>
      <pc:sldChg chg="add">
        <pc:chgData name="Koulouras, Grigorios" userId="6b492592-ea60-4083-9d49-546cfcedce02" providerId="ADAL" clId="{BA453368-2715-4F84-A1D1-33A36EA6D014}" dt="2024-12-09T22:53:02.267" v="4"/>
        <pc:sldMkLst>
          <pc:docMk/>
          <pc:sldMk cId="148565445" sldId="266"/>
        </pc:sldMkLst>
      </pc:sldChg>
      <pc:sldChg chg="add">
        <pc:chgData name="Koulouras, Grigorios" userId="6b492592-ea60-4083-9d49-546cfcedce02" providerId="ADAL" clId="{BA453368-2715-4F84-A1D1-33A36EA6D014}" dt="2024-12-09T22:53:02.267" v="4"/>
        <pc:sldMkLst>
          <pc:docMk/>
          <pc:sldMk cId="4100192692" sldId="267"/>
        </pc:sldMkLst>
      </pc:sldChg>
      <pc:sldChg chg="add">
        <pc:chgData name="Koulouras, Grigorios" userId="6b492592-ea60-4083-9d49-546cfcedce02" providerId="ADAL" clId="{BA453368-2715-4F84-A1D1-33A36EA6D014}" dt="2024-12-09T22:53:02.267" v="4"/>
        <pc:sldMkLst>
          <pc:docMk/>
          <pc:sldMk cId="1485672824" sldId="268"/>
        </pc:sldMkLst>
      </pc:sldChg>
      <pc:sldChg chg="add">
        <pc:chgData name="Koulouras, Grigorios" userId="6b492592-ea60-4083-9d49-546cfcedce02" providerId="ADAL" clId="{BA453368-2715-4F84-A1D1-33A36EA6D014}" dt="2024-12-09T22:53:02.267" v="4"/>
        <pc:sldMkLst>
          <pc:docMk/>
          <pc:sldMk cId="1477253491" sldId="269"/>
        </pc:sldMkLst>
      </pc:sldChg>
      <pc:sldChg chg="add">
        <pc:chgData name="Koulouras, Grigorios" userId="6b492592-ea60-4083-9d49-546cfcedce02" providerId="ADAL" clId="{BA453368-2715-4F84-A1D1-33A36EA6D014}" dt="2024-12-09T22:53:02.267" v="4"/>
        <pc:sldMkLst>
          <pc:docMk/>
          <pc:sldMk cId="639706638" sldId="270"/>
        </pc:sldMkLst>
      </pc:sldChg>
      <pc:sldChg chg="add">
        <pc:chgData name="Koulouras, Grigorios" userId="6b492592-ea60-4083-9d49-546cfcedce02" providerId="ADAL" clId="{BA453368-2715-4F84-A1D1-33A36EA6D014}" dt="2024-12-09T22:53:02.267" v="4"/>
        <pc:sldMkLst>
          <pc:docMk/>
          <pc:sldMk cId="3675977281" sldId="271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47A468-2375-BF2C-2B28-94A7611238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3D432F-5E46-4F9D-0087-A0D9CEC0B8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96C0AD-BB16-FDDE-036D-2439769B2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3450D-ED11-C6B9-598C-0C00FB413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A398B2-2ED7-6AAE-D36F-F3A6BD7CE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504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0E3318-9AA8-9EAE-44C1-505EE689A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93C323-B539-C48A-4590-027EAFDBF3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6B3A63-96F0-A788-2933-DF9F4F3BB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1FEBC3-0256-6C17-BBBC-90633241D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3A9BA8-7CDE-5E84-0FBC-CFDA96742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203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9794B7-BF72-90D1-71BB-08C1F6A752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0D53F6-6E00-8DA5-F7A1-7AC0FF6325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538169-C949-2512-E450-D9342CE92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8969E1-3D1C-7E8D-ED23-93556B9AE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402A65-F3C2-F2D8-BA61-76812BB44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596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1CC68-A1A1-AA72-1C15-31725FD3F2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8DAED2-0825-202F-1DDB-1630328674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314283-F94E-4A2E-5E25-15198C555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6AF053-C454-2D39-1272-B30CAE5F8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0318EE-9E67-CDED-9296-22D7DE699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146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63D259-7D0F-FD9F-96D6-82A8194398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9A9A4C-6CB9-196D-AA41-8BEF54726F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BFF0FC-7E1B-1935-F63C-AC4B3CC46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6FA35-A0B5-992E-9FA4-A3DACCC97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AA740B-BB2F-CF59-6271-FA1056437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927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44C0A6-024A-9C97-8371-C7A5428E66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E6F885-7FEB-C0A1-4582-666FC43649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53E6D7-51FB-E5F0-6464-2B0465C8DB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8CD29D-030B-AB35-75DF-DED726A21A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4D2300-FAF5-5500-3D2D-0B8A752E8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F808D2-E7C8-B8F8-6FB7-6488002B5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438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DCCDB3-D69B-41AF-6A00-06188FF3CF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7A7A18-B584-2D9A-14F0-11B603B304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5CA559-3E70-6167-50C6-6DC982F2AF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1034AC1-7BA0-8DAE-CB55-D6317DB041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F654E8-F300-739B-3861-79310501AA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075A84-AE44-5E51-116C-1EDB52557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654544-A8E9-28A9-F6AA-ECC897D66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0D134E4-FC7F-925D-26EC-C17C5436C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7529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29CA2-C18F-8F18-E2FE-F84E5FFFCE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A2D793-7F45-B4F9-3EC1-8BE11E905D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B9164C-3BA7-243E-9B8F-BDC87AC52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BF386D-EA0E-72A4-3D35-0EEA7160B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051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BD825B-68FE-02EA-107C-712F71DCB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1F938F-990E-E858-97E5-7676BE90C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755A4AE-1FA0-6981-AC8B-37F6B0B2F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027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23F40-F83A-4824-5ACA-7C1B8DFA40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97739B-6C9A-8A49-A8B0-096C63C620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0F20A7-4CBA-B962-FFFF-18FF011FE1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E9B7C5-A27F-0F39-24D2-1DC660917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B16396-3D83-423F-D018-CAD626721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03DCB6-443A-2A48-E432-C4CA31D7A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073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487302-161E-C4CD-9C9C-481F022391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375541-8903-A18A-8D57-F7E1DCC2EE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7913BA-DF92-B7EE-59C5-4006146413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0F20DC-7275-FF2D-DCB2-4BB0389FE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480112-6B75-AD1F-E3B2-54EF409AB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0BCFF9-EA2A-8B04-38A2-FA3012464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068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90BF16-246F-E9EF-B959-A098BB14A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1F0DE2-113A-C049-613E-F3314A5D15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5DF9E2-58B8-F1F2-E82D-42313930B5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C5542-0279-49B0-B9DD-1D0108D26644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5C70D8-B662-B240-3490-F0ACB067E0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8B31AB-FB77-4236-CD15-58EB7E8211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44F97-62B9-466F-AA85-D385CB463B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65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B67FC-04DF-9DEC-D301-84A7D0D7F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en-US" dirty="0"/>
              <a:t>Bulk diges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DE7CE59-36AE-81A1-F35A-A9D1DE5D5B0A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1F4308F-BE5D-67BD-9594-4BB66895B0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7032" y="976185"/>
            <a:ext cx="8097936" cy="5232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56728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FD0FDD6-13A9-3A01-94B6-939F14D39B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8275" y="553444"/>
            <a:ext cx="8039513" cy="19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53E04AD-0D10-745C-DAFE-94451B5D5C58}"/>
              </a:ext>
            </a:extLst>
          </p:cNvPr>
          <p:cNvSpPr txBox="1"/>
          <p:nvPr/>
        </p:nvSpPr>
        <p:spPr>
          <a:xfrm>
            <a:off x="9530080" y="439063"/>
            <a:ext cx="1483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ymotrypsin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07A6A6A-5545-F37B-CC4D-DCBCC38385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08328" y="2712651"/>
            <a:ext cx="2536367" cy="309067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6531134-7B6F-F1F3-984E-F50CA92D68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42340" y="2906804"/>
            <a:ext cx="2608019" cy="309067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6C82334-0FA2-A1ED-27E8-D47C1945D097}"/>
              </a:ext>
            </a:extLst>
          </p:cNvPr>
          <p:cNvSpPr txBox="1"/>
          <p:nvPr/>
        </p:nvSpPr>
        <p:spPr>
          <a:xfrm>
            <a:off x="4002404" y="4138607"/>
            <a:ext cx="2915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detectable peptides in re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F656758-1F69-A136-B514-BADEBDA4022B}"/>
              </a:ext>
            </a:extLst>
          </p:cNvPr>
          <p:cNvSpPr txBox="1"/>
          <p:nvPr/>
        </p:nvSpPr>
        <p:spPr>
          <a:xfrm>
            <a:off x="3998229" y="4485160"/>
            <a:ext cx="2813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dentifiable peptides in blu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C77D2DE-C8FB-1328-985E-89F1A30A2C56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0</a:t>
            </a:r>
          </a:p>
        </p:txBody>
      </p:sp>
    </p:spTree>
    <p:extLst>
      <p:ext uri="{BB962C8B-B14F-4D97-AF65-F5344CB8AC3E}">
        <p14:creationId xmlns:p14="http://schemas.microsoft.com/office/powerpoint/2010/main" val="25547181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D5B09-978E-02CD-86F5-967A90E375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ypsin digestio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2F961C2-E025-871D-D566-9D26D71567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4746" y="2002350"/>
            <a:ext cx="8083965" cy="358158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7FB03C4-7DDD-BCA7-2C77-861581E67D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5561" y="5712022"/>
            <a:ext cx="9601693" cy="85729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CB4C758-79C6-9988-381C-EA933F02028A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1</a:t>
            </a:r>
          </a:p>
        </p:txBody>
      </p:sp>
    </p:spTree>
    <p:extLst>
      <p:ext uri="{BB962C8B-B14F-4D97-AF65-F5344CB8AC3E}">
        <p14:creationId xmlns:p14="http://schemas.microsoft.com/office/powerpoint/2010/main" val="23488911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6C24C-2985-1EF1-BADA-05DCADE08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ymotrypsi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F05F394-4D72-BB88-9F00-D4ADFCEC00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3624" y="1690688"/>
            <a:ext cx="8083965" cy="351173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079F922-A036-504C-0EA6-357B370058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0882" y="5399122"/>
            <a:ext cx="9430235" cy="76838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D5CAA48-22EE-E2FB-BA55-A470B401666F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2</a:t>
            </a:r>
          </a:p>
        </p:txBody>
      </p:sp>
    </p:spTree>
    <p:extLst>
      <p:ext uri="{BB962C8B-B14F-4D97-AF65-F5344CB8AC3E}">
        <p14:creationId xmlns:p14="http://schemas.microsoft.com/office/powerpoint/2010/main" val="76678106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2400B6-4921-C6A1-95B2-260B688AF8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Glu-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004BD52-21F9-739F-EFBD-7E306AF585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5096" y="1647733"/>
            <a:ext cx="8026813" cy="356253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CE96CF5-D816-39C0-83BB-201AA60066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3919" y="5468315"/>
            <a:ext cx="9550891" cy="81919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39F5C02-C0DF-D6BD-B582-5B2C0503C736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3</a:t>
            </a:r>
          </a:p>
        </p:txBody>
      </p:sp>
    </p:spTree>
    <p:extLst>
      <p:ext uri="{BB962C8B-B14F-4D97-AF65-F5344CB8AC3E}">
        <p14:creationId xmlns:p14="http://schemas.microsoft.com/office/powerpoint/2010/main" val="19665130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C9A8E3-8944-EC8F-21E7-94E06FDF95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p-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1B07D24-7F04-24AC-8A8D-E1DF92FBEC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6717" y="1663609"/>
            <a:ext cx="8058564" cy="353078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6473E76-365E-9770-A955-B285B7F33F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8655" y="5503107"/>
            <a:ext cx="9474687" cy="86364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3CFBBD6-7618-5DBB-95F5-2238E0F90AA8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4</a:t>
            </a:r>
          </a:p>
        </p:txBody>
      </p:sp>
    </p:spTree>
    <p:extLst>
      <p:ext uri="{BB962C8B-B14F-4D97-AF65-F5344CB8AC3E}">
        <p14:creationId xmlns:p14="http://schemas.microsoft.com/office/powerpoint/2010/main" val="14856544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1405B-F181-ACE8-79F2-26DA3C781B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epsin (pH 1.3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8661E29-5C47-0AC8-59FE-91FFF0EEB5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1744" y="1587914"/>
            <a:ext cx="8122067" cy="356888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EEE9AA8-536E-37EE-BE2D-FFA4E422D2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0706" y="5559409"/>
            <a:ext cx="9360381" cy="61598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0AC84FB-A488-8B1B-A259-C739ED75B180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5</a:t>
            </a:r>
          </a:p>
        </p:txBody>
      </p:sp>
    </p:spTree>
    <p:extLst>
      <p:ext uri="{BB962C8B-B14F-4D97-AF65-F5344CB8AC3E}">
        <p14:creationId xmlns:p14="http://schemas.microsoft.com/office/powerpoint/2010/main" val="410019269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8A2BAB-687A-19C6-06F0-C35CE281CDD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FF2D53-6ACD-FB11-4D84-CAE934573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1325563"/>
          </a:xfrm>
        </p:spPr>
        <p:txBody>
          <a:bodyPr/>
          <a:lstStyle/>
          <a:p>
            <a:r>
              <a:rPr lang="en-US" dirty="0"/>
              <a:t>Identifiable Peptides of MUC22 Predicted by Protein Cleaver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1DE2FC-310F-E3EB-D209-AD43CCD76825}"/>
              </a:ext>
            </a:extLst>
          </p:cNvPr>
          <p:cNvSpPr txBox="1"/>
          <p:nvPr/>
        </p:nvSpPr>
        <p:spPr>
          <a:xfrm>
            <a:off x="0" y="6211669"/>
            <a:ext cx="121904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6 – Peptides from MUC22 (Protein ID: E2RYF6) predicted to be detectable. In silico analysis using Protein Cleaver.</a:t>
            </a:r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D8C1CA4B-5E1E-15D3-3456-9803366391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CCA6294-53EA-8E86-A45C-0A6BA54673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8621" y="1520727"/>
            <a:ext cx="9874757" cy="38165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554340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B7C5D8-8D30-92CD-891D-3E66625595C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5ECA68-BFFB-F1D4-8799-216F86ED17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1325563"/>
          </a:xfrm>
        </p:spPr>
        <p:txBody>
          <a:bodyPr/>
          <a:lstStyle/>
          <a:p>
            <a:r>
              <a:rPr lang="en-US" dirty="0"/>
              <a:t>MUC22 Peptides Identified in </a:t>
            </a:r>
            <a:r>
              <a:rPr lang="en-US" dirty="0" err="1"/>
              <a:t>PeptideAtlas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FA722ED-20F1-A439-98E7-668259A722FC}"/>
              </a:ext>
            </a:extLst>
          </p:cNvPr>
          <p:cNvSpPr txBox="1"/>
          <p:nvPr/>
        </p:nvSpPr>
        <p:spPr>
          <a:xfrm>
            <a:off x="-83844" y="5939134"/>
            <a:ext cx="1219042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17 - Peptides </a:t>
            </a:r>
            <a:r>
              <a:rPr lang="en-US"/>
              <a:t>from MUC22 </a:t>
            </a:r>
            <a:r>
              <a:rPr lang="en-US" dirty="0"/>
              <a:t>(Protein ID: E2RYF6) experimentally detected by mass spectrometry, according to </a:t>
            </a:r>
            <a:r>
              <a:rPr lang="en-US" dirty="0" err="1"/>
              <a:t>PeptideAtlas</a:t>
            </a:r>
            <a:r>
              <a:rPr lang="en-US" dirty="0"/>
              <a:t>. In this slide, peptides </a:t>
            </a:r>
            <a:r>
              <a:rPr lang="en-US" u="sng" dirty="0"/>
              <a:t>not detected are highlighted in blue</a:t>
            </a:r>
            <a:r>
              <a:rPr lang="en-US" dirty="0"/>
              <a:t>. No regions of the protein show evidence of detection in </a:t>
            </a:r>
            <a:r>
              <a:rPr lang="en-US" dirty="0" err="1"/>
              <a:t>PeptideAtlas</a:t>
            </a:r>
            <a:r>
              <a:rPr lang="en-US" dirty="0"/>
              <a:t>.</a:t>
            </a:r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6F503AF3-3DE6-A07D-B6BB-71475A108D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878403146">
            <a:extLst>
              <a:ext uri="{FF2B5EF4-FFF2-40B4-BE49-F238E27FC236}">
                <a16:creationId xmlns:a16="http://schemas.microsoft.com/office/drawing/2014/main" id="{0B9E149C-CF74-7319-D911-5EE37FFD7D4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4103" y="2404746"/>
            <a:ext cx="9002222" cy="18593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B6AD968-6EC7-06BD-43CA-D1621ED91C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416" y="1301640"/>
            <a:ext cx="12021168" cy="42547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6583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F217F3B-5D2F-B70A-9585-693735C9B7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B1599-DD3C-F778-7C4B-D014AD0A7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en-US" dirty="0"/>
              <a:t>Bulk diges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495596D-BE32-1C96-9D26-F647107500F1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2FEDC43-1DEB-C95F-D279-ABC3C1BC4F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0519" y="1024470"/>
            <a:ext cx="9950961" cy="52263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23441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505ACF8-FAF7-8B43-4EEB-23901221EA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C4CCB4-81D5-E1E6-CCE2-B383E750D7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en-US" dirty="0"/>
              <a:t>Bulk diges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5514E98-D2DB-95BD-CA29-D6FBEC235F07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463527B-AFBF-BBE4-9557-922F588710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0519" y="1013143"/>
            <a:ext cx="9950961" cy="5245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95978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C996E5-A4F2-9224-B1B2-59B00756519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AA068-34D4-BC1E-ABD1-2099F63D46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en-US" dirty="0"/>
              <a:t>Bulk diges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008ABE2-1DA1-BB17-0D7C-6C9A9F08331F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F6C6395-05ED-5E03-FFED-3F415BC951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0519" y="1377844"/>
            <a:ext cx="9950961" cy="41023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83041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5B928DD-6BCC-6604-31CB-07E5451DA4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920" y="439063"/>
            <a:ext cx="8045863" cy="206385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75C647E-EB8E-694F-998D-6685C73E60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4207" y="2791980"/>
            <a:ext cx="3576433" cy="371158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07F6DE3-6204-FD01-7107-53FB29FC49FC}"/>
              </a:ext>
            </a:extLst>
          </p:cNvPr>
          <p:cNvSpPr txBox="1"/>
          <p:nvPr/>
        </p:nvSpPr>
        <p:spPr>
          <a:xfrm>
            <a:off x="5120640" y="4023360"/>
            <a:ext cx="2915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detectable peptides in r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CAAC1AA-06EF-6C23-8FF5-21B337AF35EF}"/>
              </a:ext>
            </a:extLst>
          </p:cNvPr>
          <p:cNvSpPr txBox="1"/>
          <p:nvPr/>
        </p:nvSpPr>
        <p:spPr>
          <a:xfrm>
            <a:off x="9530080" y="439063"/>
            <a:ext cx="853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rypsin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E0EE205-2060-04C3-4F9E-4C9746222B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24174" y="2791104"/>
            <a:ext cx="3415668" cy="371246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3258689-1EC3-879E-7BD1-62C17A1FA1EF}"/>
              </a:ext>
            </a:extLst>
          </p:cNvPr>
          <p:cNvSpPr txBox="1"/>
          <p:nvPr/>
        </p:nvSpPr>
        <p:spPr>
          <a:xfrm>
            <a:off x="5120640" y="4392692"/>
            <a:ext cx="2813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dentifiable peptides in blu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10487DD-B4E5-AA51-405F-0DE9B3023993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6445063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7141EAB-ED6B-6C41-F09E-A7233DF592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541" y="516508"/>
            <a:ext cx="8026813" cy="196860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CB2615D-9A95-ADE2-88B3-1D37CA8716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0748" y="3012509"/>
            <a:ext cx="2825328" cy="339223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B15079D-F4CA-2588-4DFD-9D64FDD7A477}"/>
              </a:ext>
            </a:extLst>
          </p:cNvPr>
          <p:cNvSpPr txBox="1"/>
          <p:nvPr/>
        </p:nvSpPr>
        <p:spPr>
          <a:xfrm>
            <a:off x="4713544" y="4003560"/>
            <a:ext cx="2915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detectable peptides in r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9C1CF7A-BF7B-5FB9-C545-C268EC2E2582}"/>
              </a:ext>
            </a:extLst>
          </p:cNvPr>
          <p:cNvSpPr txBox="1"/>
          <p:nvPr/>
        </p:nvSpPr>
        <p:spPr>
          <a:xfrm>
            <a:off x="9530080" y="439063"/>
            <a:ext cx="1483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ymotrypsin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3874B2F-A99F-E0A5-7815-A7BDBD227A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5383" y="3012322"/>
            <a:ext cx="3057829" cy="339242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C42D226-8EFE-C3EB-3C95-0B9A4EAA5972}"/>
              </a:ext>
            </a:extLst>
          </p:cNvPr>
          <p:cNvSpPr txBox="1"/>
          <p:nvPr/>
        </p:nvSpPr>
        <p:spPr>
          <a:xfrm>
            <a:off x="4764327" y="4372892"/>
            <a:ext cx="2813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dentifiable peptides in blu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08F7193-537D-9519-FD23-B87FF85529B2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334594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0F7205A-0434-61A1-572A-E195CB7BD4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5494" y="559824"/>
            <a:ext cx="7963309" cy="189239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189D584-30F9-7F5A-93D9-08F2E5AD27E6}"/>
              </a:ext>
            </a:extLst>
          </p:cNvPr>
          <p:cNvSpPr txBox="1"/>
          <p:nvPr/>
        </p:nvSpPr>
        <p:spPr>
          <a:xfrm>
            <a:off x="9530080" y="439063"/>
            <a:ext cx="853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rypsin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E4BEBE5-D558-313C-3F3E-0B2C449087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2460" y="3044232"/>
            <a:ext cx="3198606" cy="346633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16549D5-98CD-E6E2-F385-551D78933F74}"/>
              </a:ext>
            </a:extLst>
          </p:cNvPr>
          <p:cNvSpPr txBox="1"/>
          <p:nvPr/>
        </p:nvSpPr>
        <p:spPr>
          <a:xfrm>
            <a:off x="4250081" y="3591212"/>
            <a:ext cx="2915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detectable peptides in red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C9950A8-AF80-14A5-C65C-60DFB39A24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22717" y="3063428"/>
            <a:ext cx="2890587" cy="309067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9CB6207-A84B-EA69-7583-F0AA0D1BBB74}"/>
              </a:ext>
            </a:extLst>
          </p:cNvPr>
          <p:cNvSpPr txBox="1"/>
          <p:nvPr/>
        </p:nvSpPr>
        <p:spPr>
          <a:xfrm>
            <a:off x="4250081" y="3960544"/>
            <a:ext cx="2813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dentifiable peptides in blu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3DD8D53-5F7D-9DBA-D946-239F86EF7C35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7</a:t>
            </a:r>
          </a:p>
        </p:txBody>
      </p:sp>
    </p:spTree>
    <p:extLst>
      <p:ext uri="{BB962C8B-B14F-4D97-AF65-F5344CB8AC3E}">
        <p14:creationId xmlns:p14="http://schemas.microsoft.com/office/powerpoint/2010/main" val="31271271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2F2DEB7-F656-7292-3B5E-5626C58296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1534" y="3097060"/>
            <a:ext cx="2930953" cy="309143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9858E4F-3E4A-058D-E51E-38BD5D90D424}"/>
              </a:ext>
            </a:extLst>
          </p:cNvPr>
          <p:cNvSpPr txBox="1"/>
          <p:nvPr/>
        </p:nvSpPr>
        <p:spPr>
          <a:xfrm>
            <a:off x="4002404" y="4138607"/>
            <a:ext cx="2915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detectable peptides in red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6A39FF2-8642-CFC9-B904-CFC8E017A2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0885" y="529789"/>
            <a:ext cx="7969660" cy="173998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583FAD3-999C-6CF1-45DD-BD1FC3E50E7B}"/>
              </a:ext>
            </a:extLst>
          </p:cNvPr>
          <p:cNvSpPr txBox="1"/>
          <p:nvPr/>
        </p:nvSpPr>
        <p:spPr>
          <a:xfrm>
            <a:off x="9530080" y="439063"/>
            <a:ext cx="1483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ymotrypsin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2D59DF7-6F5F-65AA-30FE-E4A2107520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96416" y="3097060"/>
            <a:ext cx="2898573" cy="309067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B24B211-1EA2-626D-7AD3-EA0220F4571C}"/>
              </a:ext>
            </a:extLst>
          </p:cNvPr>
          <p:cNvSpPr txBox="1"/>
          <p:nvPr/>
        </p:nvSpPr>
        <p:spPr>
          <a:xfrm>
            <a:off x="3998229" y="4485160"/>
            <a:ext cx="2813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dentifiable peptides in blu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F3D1E1C-B12F-8864-8F56-EF545B03CF87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8</a:t>
            </a:r>
          </a:p>
        </p:txBody>
      </p:sp>
    </p:spTree>
    <p:extLst>
      <p:ext uri="{BB962C8B-B14F-4D97-AF65-F5344CB8AC3E}">
        <p14:creationId xmlns:p14="http://schemas.microsoft.com/office/powerpoint/2010/main" val="13103403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8D01CA2-9EDF-A841-BFAB-14B0416A3E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4626" y="458275"/>
            <a:ext cx="8026813" cy="21210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792E7E4-9EAF-A077-2848-72C04138DA05}"/>
              </a:ext>
            </a:extLst>
          </p:cNvPr>
          <p:cNvSpPr txBox="1"/>
          <p:nvPr/>
        </p:nvSpPr>
        <p:spPr>
          <a:xfrm>
            <a:off x="9530080" y="439063"/>
            <a:ext cx="853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rypsin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29744F1-2F3D-8ADD-3F66-6507A3CBC1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0149" y="3103817"/>
            <a:ext cx="2771099" cy="309067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90D7C98-F61A-16E0-372E-2DC3D21CC5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88343" y="2962842"/>
            <a:ext cx="2768360" cy="309067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E83ADB2-7F74-6E98-A883-21F5BECE98B7}"/>
              </a:ext>
            </a:extLst>
          </p:cNvPr>
          <p:cNvSpPr txBox="1"/>
          <p:nvPr/>
        </p:nvSpPr>
        <p:spPr>
          <a:xfrm>
            <a:off x="4002404" y="4138607"/>
            <a:ext cx="2915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detectable peptides in re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8F76A7A-6DDC-8644-EE9C-2A4F8BB9D937}"/>
              </a:ext>
            </a:extLst>
          </p:cNvPr>
          <p:cNvSpPr txBox="1"/>
          <p:nvPr/>
        </p:nvSpPr>
        <p:spPr>
          <a:xfrm>
            <a:off x="3998229" y="4485160"/>
            <a:ext cx="2813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dentifiable peptides in blu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12299EE-0D28-B32A-361E-238FB43FB2C8}"/>
              </a:ext>
            </a:extLst>
          </p:cNvPr>
          <p:cNvSpPr txBox="1"/>
          <p:nvPr/>
        </p:nvSpPr>
        <p:spPr>
          <a:xfrm>
            <a:off x="1572" y="6488668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9</a:t>
            </a:r>
          </a:p>
        </p:txBody>
      </p:sp>
    </p:spTree>
    <p:extLst>
      <p:ext uri="{BB962C8B-B14F-4D97-AF65-F5344CB8AC3E}">
        <p14:creationId xmlns:p14="http://schemas.microsoft.com/office/powerpoint/2010/main" val="955793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c550773d-72b4-457e-8748-c03cc491aa94" xsi:nil="true"/>
    <lcf76f155ced4ddcb4097134ff3c332f xmlns="f4906faa-1766-44ce-bdb8-27517c5f7e86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E2B5C0D0B5B65488A685968BAB73D2B" ma:contentTypeVersion="11" ma:contentTypeDescription="Create a new document." ma:contentTypeScope="" ma:versionID="6ee9134412304f950fa3047e832790a7">
  <xsd:schema xmlns:xsd="http://www.w3.org/2001/XMLSchema" xmlns:xs="http://www.w3.org/2001/XMLSchema" xmlns:p="http://schemas.microsoft.com/office/2006/metadata/properties" xmlns:ns2="f4906faa-1766-44ce-bdb8-27517c5f7e86" xmlns:ns3="c550773d-72b4-457e-8748-c03cc491aa94" targetNamespace="http://schemas.microsoft.com/office/2006/metadata/properties" ma:root="true" ma:fieldsID="02192acbb223393bee0e0eec1f1a1813" ns2:_="" ns3:_="">
    <xsd:import namespace="f4906faa-1766-44ce-bdb8-27517c5f7e86"/>
    <xsd:import namespace="c550773d-72b4-457e-8748-c03cc491aa9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4906faa-1766-44ce-bdb8-27517c5f7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8f9dd247-5f48-452a-8dc4-ff9a39258eb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550773d-72b4-457e-8748-c03cc491aa94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0d17827d-b996-4096-93f9-3f586962cfc7}" ma:internalName="TaxCatchAll" ma:showField="CatchAllData" ma:web="c550773d-72b4-457e-8748-c03cc491aa9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202E04F-BA88-4B5F-B426-8A2A95C94C5D}">
  <ds:schemaRefs>
    <ds:schemaRef ds:uri="http://schemas.microsoft.com/office/2006/metadata/properties"/>
    <ds:schemaRef ds:uri="http://schemas.microsoft.com/office/infopath/2007/PartnerControls"/>
    <ds:schemaRef ds:uri="c550773d-72b4-457e-8748-c03cc491aa94"/>
    <ds:schemaRef ds:uri="f4906faa-1766-44ce-bdb8-27517c5f7e86"/>
  </ds:schemaRefs>
</ds:datastoreItem>
</file>

<file path=customXml/itemProps2.xml><?xml version="1.0" encoding="utf-8"?>
<ds:datastoreItem xmlns:ds="http://schemas.openxmlformats.org/officeDocument/2006/customXml" ds:itemID="{7397BE60-4D58-409D-94A4-F5AF1062182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4906faa-1766-44ce-bdb8-27517c5f7e86"/>
    <ds:schemaRef ds:uri="c550773d-72b4-457e-8748-c03cc491aa9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455404D-92E5-4486-B823-F4C4A448C73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018</TotalTime>
  <Words>202</Words>
  <Application>Microsoft Office PowerPoint</Application>
  <PresentationFormat>Widescreen</PresentationFormat>
  <Paragraphs>46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Bulk digestion</vt:lpstr>
      <vt:lpstr>Bulk digestion</vt:lpstr>
      <vt:lpstr>Bulk digestion</vt:lpstr>
      <vt:lpstr>Bulk diges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rypsin digestion</vt:lpstr>
      <vt:lpstr>Chymotrypsin</vt:lpstr>
      <vt:lpstr>Glu-C</vt:lpstr>
      <vt:lpstr>Asp-N</vt:lpstr>
      <vt:lpstr>Pepsin (pH 1.3)</vt:lpstr>
      <vt:lpstr>Identifiable Peptides of MUC22 Predicted by Protein Cleaver</vt:lpstr>
      <vt:lpstr>MUC22 Peptides Identified in PeptideAtla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u, Mary (Yingrong)</dc:creator>
  <cp:lastModifiedBy>Koulouras, Grigorios</cp:lastModifiedBy>
  <cp:revision>1</cp:revision>
  <dcterms:created xsi:type="dcterms:W3CDTF">2024-08-28T19:17:58Z</dcterms:created>
  <dcterms:modified xsi:type="dcterms:W3CDTF">2025-07-18T14:45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791b42f-c435-42ca-9531-75a3f42aae3d_Enabled">
    <vt:lpwstr>true</vt:lpwstr>
  </property>
  <property fmtid="{D5CDD505-2E9C-101B-9397-08002B2CF9AE}" pid="3" name="MSIP_Label_4791b42f-c435-42ca-9531-75a3f42aae3d_SetDate">
    <vt:lpwstr>2024-08-28T19:21:19Z</vt:lpwstr>
  </property>
  <property fmtid="{D5CDD505-2E9C-101B-9397-08002B2CF9AE}" pid="4" name="MSIP_Label_4791b42f-c435-42ca-9531-75a3f42aae3d_Method">
    <vt:lpwstr>Privileged</vt:lpwstr>
  </property>
  <property fmtid="{D5CDD505-2E9C-101B-9397-08002B2CF9AE}" pid="5" name="MSIP_Label_4791b42f-c435-42ca-9531-75a3f42aae3d_Name">
    <vt:lpwstr>4791b42f-c435-42ca-9531-75a3f42aae3d</vt:lpwstr>
  </property>
  <property fmtid="{D5CDD505-2E9C-101B-9397-08002B2CF9AE}" pid="6" name="MSIP_Label_4791b42f-c435-42ca-9531-75a3f42aae3d_SiteId">
    <vt:lpwstr>7a916015-20ae-4ad1-9170-eefd915e9272</vt:lpwstr>
  </property>
  <property fmtid="{D5CDD505-2E9C-101B-9397-08002B2CF9AE}" pid="7" name="MSIP_Label_4791b42f-c435-42ca-9531-75a3f42aae3d_ActionId">
    <vt:lpwstr>8f15d0ac-76c2-47fe-b67e-5870ef9c10f9</vt:lpwstr>
  </property>
  <property fmtid="{D5CDD505-2E9C-101B-9397-08002B2CF9AE}" pid="8" name="MSIP_Label_4791b42f-c435-42ca-9531-75a3f42aae3d_ContentBits">
    <vt:lpwstr>0</vt:lpwstr>
  </property>
  <property fmtid="{D5CDD505-2E9C-101B-9397-08002B2CF9AE}" pid="9" name="ContentTypeId">
    <vt:lpwstr>0x010100AE2B5C0D0B5B65488A685968BAB73D2B</vt:lpwstr>
  </property>
  <property fmtid="{D5CDD505-2E9C-101B-9397-08002B2CF9AE}" pid="10" name="MediaServiceImageTags">
    <vt:lpwstr/>
  </property>
</Properties>
</file>